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56" autoAdjust="0"/>
    <p:restoredTop sz="96586" autoAdjust="0"/>
  </p:normalViewPr>
  <p:slideViewPr>
    <p:cSldViewPr snapToGrid="0">
      <p:cViewPr varScale="1">
        <p:scale>
          <a:sx n="79" d="100"/>
          <a:sy n="79" d="100"/>
        </p:scale>
        <p:origin x="3048" y="9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72" d="100"/>
        <a:sy n="17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\\ME-FILER2\GROUPS2$\IMS\TVP\stefania\fibrates%20liver%20gene%20expression%20june%202016\summary%20fibrates%20data%20august%202016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\\ME-FILER2\GROUPS2$\IMS\TVP\stefania\fibrates%20liver%20gene%20expression%20june%202016\summary%20fibrates%20data%20august%202016.xls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\\ME-FILER2\GROUPS2$\IMS\TVP\stefania\fibrates%20liver%20gene%20expression%20june%202016\summary%20fibrates%20data%20august%202016.xls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\\ME-FILER2\GROUPS2$\IMS\TVP\stefania\fibrates%20liver%20gene%20expression%20june%202016\summary%20fibrates%20data%20august%202016.xls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\\ME-FILER2\GROUPS2$\IMS\TVP\stefania\fibrates%20liver%20gene%20expression%20june%202016\summary%20fibrates%20data%20august%202016.xls" TargetMode="External"/><Relationship Id="rId1" Type="http://schemas.openxmlformats.org/officeDocument/2006/relationships/themeOverride" Target="../theme/themeOverrid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8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GB" sz="1000" dirty="0"/>
              <a:t>SCD1 index</a:t>
            </a:r>
          </a:p>
        </c:rich>
      </c:tx>
      <c:layout>
        <c:manualLayout>
          <c:xMode val="edge"/>
          <c:yMode val="edge"/>
          <c:x val="0.20146436080428795"/>
          <c:y val="0.10008672219942495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8663778698129727"/>
          <c:y val="9.7902350386847664E-2"/>
          <c:w val="0.73948845729176804"/>
          <c:h val="0.8041952992263046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</c:dPt>
          <c:dPt>
            <c:idx val="4"/>
            <c:invertIfNegative val="0"/>
            <c:bubble3D val="0"/>
            <c:spPr>
              <a:solidFill>
                <a:schemeClr val="accent3">
                  <a:lumMod val="40000"/>
                  <a:lumOff val="60000"/>
                </a:schemeClr>
              </a:solidFill>
            </c:spPr>
          </c:dPt>
          <c:dPt>
            <c:idx val="5"/>
            <c:invertIfNegative val="0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</c:spPr>
          </c:dPt>
          <c:dPt>
            <c:idx val="6"/>
            <c:invertIfNegative val="0"/>
            <c:bubble3D val="0"/>
            <c:spPr>
              <a:solidFill>
                <a:schemeClr val="accent3">
                  <a:lumMod val="75000"/>
                </a:schemeClr>
              </a:solidFill>
            </c:spPr>
          </c:dPt>
          <c:dPt>
            <c:idx val="7"/>
            <c:invertIfNegative val="0"/>
            <c:bubble3D val="0"/>
            <c:spPr>
              <a:solidFill>
                <a:schemeClr val="accent3">
                  <a:lumMod val="50000"/>
                </a:schemeClr>
              </a:solidFill>
            </c:spPr>
          </c:dPt>
          <c:errBars>
            <c:errBarType val="plus"/>
            <c:errValType val="cust"/>
            <c:noEndCap val="0"/>
            <c:plus>
              <c:numRef>
                <c:f>'ffa profileREMOD'!$S$100:$S$107</c:f>
                <c:numCache>
                  <c:formatCode>General</c:formatCode>
                  <c:ptCount val="8"/>
                  <c:pt idx="0">
                    <c:v>1.6114486893869826E-2</c:v>
                  </c:pt>
                  <c:pt idx="1">
                    <c:v>3.3371984039189E-2</c:v>
                  </c:pt>
                  <c:pt idx="2">
                    <c:v>4.5893640483222531E-2</c:v>
                  </c:pt>
                  <c:pt idx="3">
                    <c:v>5.0407908377634453E-2</c:v>
                  </c:pt>
                  <c:pt idx="4">
                    <c:v>8.7523507072371332E-2</c:v>
                  </c:pt>
                  <c:pt idx="5">
                    <c:v>8.2625009951546632E-2</c:v>
                  </c:pt>
                  <c:pt idx="6">
                    <c:v>7.7865019637418653E-2</c:v>
                  </c:pt>
                  <c:pt idx="7">
                    <c:v>7.4090457540213789E-2</c:v>
                  </c:pt>
                </c:numCache>
              </c:numRef>
            </c:plus>
          </c:errBars>
          <c:val>
            <c:numRef>
              <c:f>'ffa profileREMOD'!$R$100:$R$107</c:f>
              <c:numCache>
                <c:formatCode>General</c:formatCode>
                <c:ptCount val="8"/>
                <c:pt idx="0">
                  <c:v>0.39498634763584178</c:v>
                </c:pt>
                <c:pt idx="1">
                  <c:v>0.48623356930108325</c:v>
                </c:pt>
                <c:pt idx="2">
                  <c:v>0.44057652542842141</c:v>
                </c:pt>
                <c:pt idx="3">
                  <c:v>0.38939065231904513</c:v>
                </c:pt>
                <c:pt idx="4">
                  <c:v>0.68668874877382291</c:v>
                </c:pt>
                <c:pt idx="5">
                  <c:v>0.81325029424200435</c:v>
                </c:pt>
                <c:pt idx="6">
                  <c:v>1.0131748627788961</c:v>
                </c:pt>
                <c:pt idx="7">
                  <c:v>1.16416418356565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"/>
        <c:axId val="280781832"/>
        <c:axId val="280782224"/>
      </c:barChart>
      <c:catAx>
        <c:axId val="28078183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80782224"/>
        <c:crosses val="autoZero"/>
        <c:auto val="1"/>
        <c:lblAlgn val="ctr"/>
        <c:lblOffset val="100"/>
        <c:noMultiLvlLbl val="0"/>
      </c:catAx>
      <c:valAx>
        <c:axId val="2807822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280781832"/>
        <c:crosses val="autoZero"/>
        <c:crossBetween val="between"/>
      </c:valAx>
      <c:spPr>
        <a:ln>
          <a:solidFill>
            <a:schemeClr val="accent1"/>
          </a:solidFill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8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GB" sz="1000" dirty="0"/>
              <a:t>ELOVL6 index</a:t>
            </a:r>
          </a:p>
        </c:rich>
      </c:tx>
      <c:layout>
        <c:manualLayout>
          <c:xMode val="edge"/>
          <c:yMode val="edge"/>
          <c:x val="0.18131697287876031"/>
          <c:y val="0.10008672219942495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</c:dPt>
          <c:dPt>
            <c:idx val="4"/>
            <c:invertIfNegative val="0"/>
            <c:bubble3D val="0"/>
            <c:spPr>
              <a:solidFill>
                <a:schemeClr val="accent3">
                  <a:lumMod val="40000"/>
                  <a:lumOff val="60000"/>
                </a:schemeClr>
              </a:solidFill>
            </c:spPr>
          </c:dPt>
          <c:dPt>
            <c:idx val="5"/>
            <c:invertIfNegative val="0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</c:spPr>
          </c:dPt>
          <c:dPt>
            <c:idx val="6"/>
            <c:invertIfNegative val="0"/>
            <c:bubble3D val="0"/>
            <c:spPr>
              <a:solidFill>
                <a:schemeClr val="accent3">
                  <a:lumMod val="75000"/>
                </a:schemeClr>
              </a:solidFill>
            </c:spPr>
          </c:dPt>
          <c:dPt>
            <c:idx val="7"/>
            <c:invertIfNegative val="0"/>
            <c:bubble3D val="0"/>
            <c:spPr>
              <a:solidFill>
                <a:schemeClr val="accent3">
                  <a:lumMod val="50000"/>
                </a:schemeClr>
              </a:solidFill>
            </c:spPr>
          </c:dPt>
          <c:errBars>
            <c:errBarType val="plus"/>
            <c:errValType val="cust"/>
            <c:noEndCap val="0"/>
            <c:plus>
              <c:numRef>
                <c:f>'ffa profileREMOD'!$U$100:$U$107</c:f>
                <c:numCache>
                  <c:formatCode>General</c:formatCode>
                  <c:ptCount val="8"/>
                  <c:pt idx="0">
                    <c:v>7.1142780967493366E-2</c:v>
                  </c:pt>
                  <c:pt idx="1">
                    <c:v>3.0797689791606023E-2</c:v>
                  </c:pt>
                  <c:pt idx="2">
                    <c:v>8.7256022835351055E-2</c:v>
                  </c:pt>
                  <c:pt idx="3">
                    <c:v>7.0639087716535279E-2</c:v>
                  </c:pt>
                  <c:pt idx="4">
                    <c:v>0.20293032549270221</c:v>
                  </c:pt>
                  <c:pt idx="5">
                    <c:v>3.7356582547463268E-2</c:v>
                  </c:pt>
                  <c:pt idx="6">
                    <c:v>6.9096628333140411E-2</c:v>
                  </c:pt>
                  <c:pt idx="7">
                    <c:v>3.8127983647474183E-2</c:v>
                  </c:pt>
                </c:numCache>
              </c:numRef>
            </c:plus>
          </c:errBars>
          <c:val>
            <c:numRef>
              <c:f>'ffa profileREMOD'!$T$100:$T$107</c:f>
              <c:numCache>
                <c:formatCode>General</c:formatCode>
                <c:ptCount val="8"/>
                <c:pt idx="0">
                  <c:v>1.079209021502924</c:v>
                </c:pt>
                <c:pt idx="1">
                  <c:v>0.79916075489453609</c:v>
                </c:pt>
                <c:pt idx="2">
                  <c:v>1.0541443219370363</c:v>
                </c:pt>
                <c:pt idx="3">
                  <c:v>0.96169489602168423</c:v>
                </c:pt>
                <c:pt idx="4">
                  <c:v>1.8612294940633825</c:v>
                </c:pt>
                <c:pt idx="5">
                  <c:v>1.587271422224749</c:v>
                </c:pt>
                <c:pt idx="6">
                  <c:v>1.6400901408431952</c:v>
                </c:pt>
                <c:pt idx="7">
                  <c:v>1.469012336374635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"/>
        <c:axId val="280783008"/>
        <c:axId val="400153832"/>
      </c:barChart>
      <c:catAx>
        <c:axId val="28078300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400153832"/>
        <c:crosses val="autoZero"/>
        <c:auto val="1"/>
        <c:lblAlgn val="ctr"/>
        <c:lblOffset val="100"/>
        <c:noMultiLvlLbl val="0"/>
      </c:catAx>
      <c:valAx>
        <c:axId val="4001538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280783008"/>
        <c:crosses val="autoZero"/>
        <c:crossBetween val="between"/>
      </c:valAx>
      <c:spPr>
        <a:ln>
          <a:solidFill>
            <a:schemeClr val="accent1"/>
          </a:solidFill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8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GB" sz="1000" dirty="0"/>
              <a:t>FADS1 (D5D</a:t>
            </a:r>
            <a:r>
              <a:rPr lang="en-GB" sz="1000" dirty="0" smtClean="0"/>
              <a:t>) index</a:t>
            </a:r>
            <a:endParaRPr lang="en-GB" sz="1000" dirty="0"/>
          </a:p>
        </c:rich>
      </c:tx>
      <c:layout>
        <c:manualLayout>
          <c:xMode val="edge"/>
          <c:yMode val="edge"/>
          <c:x val="0.13430640105252917"/>
          <c:y val="9.1268692313941302E-2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</c:dPt>
          <c:dPt>
            <c:idx val="4"/>
            <c:invertIfNegative val="0"/>
            <c:bubble3D val="0"/>
            <c:spPr>
              <a:solidFill>
                <a:schemeClr val="accent3">
                  <a:lumMod val="40000"/>
                  <a:lumOff val="60000"/>
                </a:schemeClr>
              </a:solidFill>
            </c:spPr>
          </c:dPt>
          <c:dPt>
            <c:idx val="5"/>
            <c:invertIfNegative val="0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</c:spPr>
          </c:dPt>
          <c:dPt>
            <c:idx val="6"/>
            <c:invertIfNegative val="0"/>
            <c:bubble3D val="0"/>
            <c:spPr>
              <a:solidFill>
                <a:schemeClr val="accent3">
                  <a:lumMod val="75000"/>
                </a:schemeClr>
              </a:solidFill>
            </c:spPr>
          </c:dPt>
          <c:dPt>
            <c:idx val="7"/>
            <c:invertIfNegative val="0"/>
            <c:bubble3D val="0"/>
            <c:spPr>
              <a:solidFill>
                <a:schemeClr val="accent3">
                  <a:lumMod val="50000"/>
                </a:schemeClr>
              </a:solidFill>
            </c:spPr>
          </c:dPt>
          <c:errBars>
            <c:errBarType val="plus"/>
            <c:errValType val="cust"/>
            <c:noEndCap val="0"/>
            <c:plus>
              <c:numRef>
                <c:f>'ffa profileREMOD'!$O$100:$O$107</c:f>
                <c:numCache>
                  <c:formatCode>General</c:formatCode>
                  <c:ptCount val="8"/>
                  <c:pt idx="0">
                    <c:v>0.40704274540644642</c:v>
                  </c:pt>
                  <c:pt idx="1">
                    <c:v>0.13578327953513095</c:v>
                  </c:pt>
                  <c:pt idx="2">
                    <c:v>0.35130186605922292</c:v>
                  </c:pt>
                  <c:pt idx="3">
                    <c:v>0.5357789514478366</c:v>
                  </c:pt>
                  <c:pt idx="4">
                    <c:v>0.28073697773625211</c:v>
                  </c:pt>
                  <c:pt idx="5">
                    <c:v>0.26003077348017201</c:v>
                  </c:pt>
                  <c:pt idx="6">
                    <c:v>0.37031445107700406</c:v>
                  </c:pt>
                  <c:pt idx="7">
                    <c:v>0.10209544537718056</c:v>
                  </c:pt>
                </c:numCache>
              </c:numRef>
            </c:plus>
          </c:errBars>
          <c:val>
            <c:numRef>
              <c:f>'ffa profileREMOD'!$N$100:$N$107</c:f>
              <c:numCache>
                <c:formatCode>General</c:formatCode>
                <c:ptCount val="8"/>
                <c:pt idx="0">
                  <c:v>5.3570048309178748</c:v>
                </c:pt>
                <c:pt idx="1">
                  <c:v>2.8689328530819074</c:v>
                </c:pt>
                <c:pt idx="2">
                  <c:v>4.1838042407836458</c:v>
                </c:pt>
                <c:pt idx="3">
                  <c:v>4.1333063063063067</c:v>
                </c:pt>
                <c:pt idx="4">
                  <c:v>6.7251543180201141</c:v>
                </c:pt>
                <c:pt idx="5">
                  <c:v>3.1555122655122654</c:v>
                </c:pt>
                <c:pt idx="6">
                  <c:v>4.2296953242835595</c:v>
                </c:pt>
                <c:pt idx="7">
                  <c:v>2.56262875055978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"/>
        <c:axId val="400154616"/>
        <c:axId val="400155008"/>
      </c:barChart>
      <c:catAx>
        <c:axId val="40015461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400155008"/>
        <c:crosses val="autoZero"/>
        <c:auto val="1"/>
        <c:lblAlgn val="ctr"/>
        <c:lblOffset val="100"/>
        <c:noMultiLvlLbl val="0"/>
      </c:catAx>
      <c:valAx>
        <c:axId val="4001550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400154616"/>
        <c:crosses val="autoZero"/>
        <c:crossBetween val="between"/>
      </c:valAx>
      <c:spPr>
        <a:ln>
          <a:solidFill>
            <a:schemeClr val="accent1"/>
          </a:solidFill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8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GB" sz="1000" dirty="0"/>
              <a:t>FADS2 (D6D</a:t>
            </a:r>
            <a:r>
              <a:rPr lang="en-GB" sz="1000" dirty="0" smtClean="0"/>
              <a:t>) index</a:t>
            </a:r>
            <a:endParaRPr lang="en-GB" sz="1000" dirty="0"/>
          </a:p>
        </c:rich>
      </c:tx>
      <c:layout>
        <c:manualLayout>
          <c:xMode val="edge"/>
          <c:yMode val="edge"/>
          <c:x val="0.1947485648291121"/>
          <c:y val="9.1268692313941302E-2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</c:dPt>
          <c:dPt>
            <c:idx val="4"/>
            <c:invertIfNegative val="0"/>
            <c:bubble3D val="0"/>
            <c:spPr>
              <a:solidFill>
                <a:schemeClr val="accent3">
                  <a:lumMod val="40000"/>
                  <a:lumOff val="60000"/>
                </a:schemeClr>
              </a:solidFill>
            </c:spPr>
          </c:dPt>
          <c:dPt>
            <c:idx val="5"/>
            <c:invertIfNegative val="0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</c:spPr>
          </c:dPt>
          <c:dPt>
            <c:idx val="6"/>
            <c:invertIfNegative val="0"/>
            <c:bubble3D val="0"/>
            <c:spPr>
              <a:solidFill>
                <a:schemeClr val="accent3">
                  <a:lumMod val="75000"/>
                </a:schemeClr>
              </a:solidFill>
            </c:spPr>
          </c:dPt>
          <c:dPt>
            <c:idx val="7"/>
            <c:invertIfNegative val="0"/>
            <c:bubble3D val="0"/>
            <c:spPr>
              <a:solidFill>
                <a:schemeClr val="accent3">
                  <a:lumMod val="50000"/>
                </a:schemeClr>
              </a:solidFill>
            </c:spPr>
          </c:dPt>
          <c:errBars>
            <c:errBarType val="both"/>
            <c:errValType val="cust"/>
            <c:noEndCap val="0"/>
            <c:plus>
              <c:numRef>
                <c:f>'ffa profileREMOD'!$Q$100:$Q$107</c:f>
                <c:numCache>
                  <c:formatCode>General</c:formatCode>
                  <c:ptCount val="8"/>
                  <c:pt idx="0">
                    <c:v>8.1914534223261511E-3</c:v>
                  </c:pt>
                  <c:pt idx="1">
                    <c:v>1.853891150811246E-2</c:v>
                  </c:pt>
                  <c:pt idx="2">
                    <c:v>2.3567625499060794E-2</c:v>
                  </c:pt>
                  <c:pt idx="3">
                    <c:v>1.9293894622816176E-2</c:v>
                  </c:pt>
                  <c:pt idx="4">
                    <c:v>1.610799660000951E-2</c:v>
                  </c:pt>
                  <c:pt idx="5">
                    <c:v>2.6054041712418107E-2</c:v>
                  </c:pt>
                  <c:pt idx="6">
                    <c:v>9.4616759530111675E-3</c:v>
                  </c:pt>
                  <c:pt idx="7">
                    <c:v>2.0087712840879349E-2</c:v>
                  </c:pt>
                </c:numCache>
              </c:numRef>
            </c:plus>
            <c:minus>
              <c:numRef>
                <c:f>'ffa profileREMOD'!$Q$100:$Q$107</c:f>
                <c:numCache>
                  <c:formatCode>General</c:formatCode>
                  <c:ptCount val="8"/>
                  <c:pt idx="0">
                    <c:v>8.1914534223261511E-3</c:v>
                  </c:pt>
                  <c:pt idx="1">
                    <c:v>1.853891150811246E-2</c:v>
                  </c:pt>
                  <c:pt idx="2">
                    <c:v>2.3567625499060794E-2</c:v>
                  </c:pt>
                  <c:pt idx="3">
                    <c:v>1.9293894622816176E-2</c:v>
                  </c:pt>
                  <c:pt idx="4">
                    <c:v>1.610799660000951E-2</c:v>
                  </c:pt>
                  <c:pt idx="5">
                    <c:v>2.6054041712418107E-2</c:v>
                  </c:pt>
                  <c:pt idx="6">
                    <c:v>9.4616759530111675E-3</c:v>
                  </c:pt>
                  <c:pt idx="7">
                    <c:v>2.0087712840879349E-2</c:v>
                  </c:pt>
                </c:numCache>
              </c:numRef>
            </c:minus>
          </c:errBars>
          <c:val>
            <c:numRef>
              <c:f>'ffa profileREMOD'!$P$100:$P$107</c:f>
              <c:numCache>
                <c:formatCode>General</c:formatCode>
                <c:ptCount val="8"/>
                <c:pt idx="0">
                  <c:v>0.11061518878724155</c:v>
                </c:pt>
                <c:pt idx="1">
                  <c:v>0.18394007722381542</c:v>
                </c:pt>
                <c:pt idx="2">
                  <c:v>0.14322407514135824</c:v>
                </c:pt>
                <c:pt idx="3">
                  <c:v>0.16316157049105989</c:v>
                </c:pt>
                <c:pt idx="4">
                  <c:v>8.6230766079947965E-2</c:v>
                </c:pt>
                <c:pt idx="5">
                  <c:v>0.22048104664372375</c:v>
                </c:pt>
                <c:pt idx="6">
                  <c:v>6.8676678702632013E-2</c:v>
                </c:pt>
                <c:pt idx="7">
                  <c:v>0.1061032044331594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"/>
        <c:axId val="458037272"/>
        <c:axId val="458037664"/>
      </c:barChart>
      <c:catAx>
        <c:axId val="45803727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458037664"/>
        <c:crosses val="autoZero"/>
        <c:auto val="1"/>
        <c:lblAlgn val="ctr"/>
        <c:lblOffset val="100"/>
        <c:noMultiLvlLbl val="0"/>
      </c:catAx>
      <c:valAx>
        <c:axId val="4580376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10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458037272"/>
        <c:crosses val="autoZero"/>
        <c:crossBetween val="between"/>
      </c:valAx>
      <c:spPr>
        <a:ln>
          <a:solidFill>
            <a:schemeClr val="accent1"/>
          </a:solidFill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8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r>
              <a:rPr lang="en-GB" sz="1200" dirty="0" smtClean="0"/>
              <a:t>HEPATIC</a:t>
            </a:r>
            <a:r>
              <a:rPr lang="en-GB" sz="1200" baseline="0" dirty="0" smtClean="0"/>
              <a:t> GLYGOGEN</a:t>
            </a:r>
            <a:endParaRPr lang="en-GB" sz="1200" dirty="0"/>
          </a:p>
        </c:rich>
      </c:tx>
      <c:layout>
        <c:manualLayout>
          <c:xMode val="edge"/>
          <c:yMode val="edge"/>
          <c:x val="0.33409607308511974"/>
          <c:y val="7.150967479965184E-2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95000"/>
                </a:schemeClr>
              </a:solidFill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</c:spPr>
          </c:dPt>
          <c:dPt>
            <c:idx val="4"/>
            <c:invertIfNegative val="0"/>
            <c:bubble3D val="0"/>
            <c:spPr>
              <a:solidFill>
                <a:schemeClr val="accent3">
                  <a:lumMod val="40000"/>
                  <a:lumOff val="60000"/>
                </a:schemeClr>
              </a:solidFill>
            </c:spPr>
          </c:dPt>
          <c:dPt>
            <c:idx val="5"/>
            <c:invertIfNegative val="0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</c:spPr>
          </c:dPt>
          <c:dPt>
            <c:idx val="6"/>
            <c:invertIfNegative val="0"/>
            <c:bubble3D val="0"/>
            <c:spPr>
              <a:solidFill>
                <a:schemeClr val="accent3">
                  <a:lumMod val="75000"/>
                </a:schemeClr>
              </a:solidFill>
            </c:spPr>
          </c:dPt>
          <c:dPt>
            <c:idx val="7"/>
            <c:invertIfNegative val="0"/>
            <c:bubble3D val="0"/>
            <c:spPr>
              <a:solidFill>
                <a:schemeClr val="accent3">
                  <a:lumMod val="50000"/>
                </a:schemeClr>
              </a:solidFill>
            </c:spPr>
          </c:dPt>
          <c:errBars>
            <c:errBarType val="plus"/>
            <c:errValType val="cust"/>
            <c:noEndCap val="0"/>
            <c:plus>
              <c:numRef>
                <c:f>'liver glycogen REMOD'!$E$2:$E$9</c:f>
                <c:numCache>
                  <c:formatCode>General</c:formatCode>
                  <c:ptCount val="8"/>
                  <c:pt idx="0">
                    <c:v>3.1870905439022656E-4</c:v>
                  </c:pt>
                  <c:pt idx="1">
                    <c:v>3.9038562062140148E-4</c:v>
                  </c:pt>
                  <c:pt idx="2">
                    <c:v>5.1906375674057445E-4</c:v>
                  </c:pt>
                  <c:pt idx="3">
                    <c:v>3.7093922698503112E-4</c:v>
                  </c:pt>
                  <c:pt idx="4">
                    <c:v>1.779919102732321E-4</c:v>
                  </c:pt>
                  <c:pt idx="5">
                    <c:v>1.1095465501190921E-4</c:v>
                  </c:pt>
                  <c:pt idx="6">
                    <c:v>2.843781790640082E-4</c:v>
                  </c:pt>
                  <c:pt idx="7">
                    <c:v>2.2710134901578451E-4</c:v>
                  </c:pt>
                </c:numCache>
              </c:numRef>
            </c:plus>
          </c:errBars>
          <c:cat>
            <c:strRef>
              <c:f>'TG liver summary'!$A$2:$A$9</c:f>
              <c:strCache>
                <c:ptCount val="8"/>
                <c:pt idx="0">
                  <c:v>WT</c:v>
                </c:pt>
                <c:pt idx="1">
                  <c:v>MUT</c:v>
                </c:pt>
                <c:pt idx="2">
                  <c:v>WTF</c:v>
                </c:pt>
                <c:pt idx="3">
                  <c:v>MUTF</c:v>
                </c:pt>
                <c:pt idx="4">
                  <c:v>WT</c:v>
                </c:pt>
                <c:pt idx="5">
                  <c:v>MUT</c:v>
                </c:pt>
                <c:pt idx="6">
                  <c:v>WTF</c:v>
                </c:pt>
                <c:pt idx="7">
                  <c:v>MUTF</c:v>
                </c:pt>
              </c:strCache>
            </c:strRef>
          </c:cat>
          <c:val>
            <c:numRef>
              <c:f>'liver glycogen REMOD'!$D$2:$D$9</c:f>
              <c:numCache>
                <c:formatCode>General</c:formatCode>
                <c:ptCount val="8"/>
                <c:pt idx="0">
                  <c:v>1.7852593450506809E-3</c:v>
                </c:pt>
                <c:pt idx="1">
                  <c:v>1.741158743531829E-3</c:v>
                </c:pt>
                <c:pt idx="2">
                  <c:v>2.5284409548853477E-3</c:v>
                </c:pt>
                <c:pt idx="3">
                  <c:v>2.4045258337123399E-3</c:v>
                </c:pt>
                <c:pt idx="4">
                  <c:v>8.5064098937713052E-4</c:v>
                </c:pt>
                <c:pt idx="5">
                  <c:v>4.9050675797982488E-4</c:v>
                </c:pt>
                <c:pt idx="6">
                  <c:v>1.0816449726867025E-3</c:v>
                </c:pt>
                <c:pt idx="7">
                  <c:v>7.7287452716692014E-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"/>
        <c:axId val="458038448"/>
        <c:axId val="458038840"/>
      </c:barChart>
      <c:catAx>
        <c:axId val="45803844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458038840"/>
        <c:crosses val="autoZero"/>
        <c:auto val="1"/>
        <c:lblAlgn val="ctr"/>
        <c:lblOffset val="100"/>
        <c:noMultiLvlLbl val="0"/>
      </c:catAx>
      <c:valAx>
        <c:axId val="45803884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000" b="1" i="0" u="none" strike="noStrike" baseline="0">
                    <a:solidFill>
                      <a:srgbClr val="000000"/>
                    </a:solidFill>
                    <a:latin typeface="Calibri"/>
                    <a:ea typeface="Calibri"/>
                    <a:cs typeface="Calibri"/>
                  </a:defRPr>
                </a:pPr>
                <a:r>
                  <a:rPr lang="en-GB"/>
                  <a:t>mg/g liver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800" b="1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458038448"/>
        <c:crosses val="autoZero"/>
        <c:crossBetween val="between"/>
      </c:valAx>
      <c:spPr>
        <a:ln>
          <a:solidFill>
            <a:schemeClr val="accent1"/>
          </a:solidFill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5555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0316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6656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5853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191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2844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6733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7626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1109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6097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4484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2543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openxmlformats.org/officeDocument/2006/relationships/chart" Target="../charts/chart2.xml"/><Relationship Id="rId7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5821746" y="9419573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FIG 2</a:t>
            </a:r>
            <a:endParaRPr lang="en-GB" dirty="0"/>
          </a:p>
        </p:txBody>
      </p:sp>
      <p:grpSp>
        <p:nvGrpSpPr>
          <p:cNvPr id="64" name="Group 63"/>
          <p:cNvGrpSpPr/>
          <p:nvPr/>
        </p:nvGrpSpPr>
        <p:grpSpPr>
          <a:xfrm>
            <a:off x="2467348" y="9419573"/>
            <a:ext cx="2651571" cy="215444"/>
            <a:chOff x="3886725" y="413334"/>
            <a:chExt cx="2651571" cy="215444"/>
          </a:xfrm>
        </p:grpSpPr>
        <p:sp>
          <p:nvSpPr>
            <p:cNvPr id="65" name="Oval 64"/>
            <p:cNvSpPr/>
            <p:nvPr/>
          </p:nvSpPr>
          <p:spPr>
            <a:xfrm>
              <a:off x="3886725" y="485046"/>
              <a:ext cx="70339" cy="63304"/>
            </a:xfrm>
            <a:prstGeom prst="ellips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6" name="Oval 65"/>
            <p:cNvSpPr/>
            <p:nvPr/>
          </p:nvSpPr>
          <p:spPr>
            <a:xfrm>
              <a:off x="4193833" y="485046"/>
              <a:ext cx="70339" cy="63304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7" name="Oval 66"/>
            <p:cNvSpPr/>
            <p:nvPr/>
          </p:nvSpPr>
          <p:spPr>
            <a:xfrm>
              <a:off x="4458699" y="485046"/>
              <a:ext cx="70339" cy="63304"/>
            </a:xfrm>
            <a:prstGeom prst="ellipse">
              <a:avLst/>
            </a:prstGeom>
            <a:solidFill>
              <a:srgbClr val="92D05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8" name="Oval 67"/>
            <p:cNvSpPr/>
            <p:nvPr/>
          </p:nvSpPr>
          <p:spPr>
            <a:xfrm>
              <a:off x="4737980" y="485046"/>
              <a:ext cx="70339" cy="6330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9" name="Oval 68"/>
            <p:cNvSpPr/>
            <p:nvPr/>
          </p:nvSpPr>
          <p:spPr>
            <a:xfrm>
              <a:off x="5131840" y="498095"/>
              <a:ext cx="70339" cy="63304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0" name="Oval 69"/>
            <p:cNvSpPr/>
            <p:nvPr/>
          </p:nvSpPr>
          <p:spPr>
            <a:xfrm>
              <a:off x="5534176" y="503461"/>
              <a:ext cx="70339" cy="63304"/>
            </a:xfrm>
            <a:prstGeom prst="ellips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1" name="Oval 70"/>
            <p:cNvSpPr/>
            <p:nvPr/>
          </p:nvSpPr>
          <p:spPr>
            <a:xfrm>
              <a:off x="5928336" y="506972"/>
              <a:ext cx="70339" cy="63304"/>
            </a:xfrm>
            <a:prstGeom prst="ellipse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3929765" y="413334"/>
              <a:ext cx="2487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G</a:t>
              </a:r>
              <a:endParaRPr lang="en-GB" sz="800" b="1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4238097" y="41333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T</a:t>
              </a:r>
              <a:endParaRPr lang="en-GB" sz="800" b="1" dirty="0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4508226" y="413334"/>
              <a:ext cx="2487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D</a:t>
              </a:r>
              <a:endParaRPr lang="en-GB" sz="800" b="1" dirty="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4790889" y="413334"/>
              <a:ext cx="4026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G x T</a:t>
              </a:r>
              <a:endParaRPr lang="en-GB" sz="800" b="1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5166100" y="413334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G x D</a:t>
              </a:r>
              <a:endParaRPr lang="en-GB" sz="800" b="1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5970512" y="413334"/>
              <a:ext cx="5677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G x T x D</a:t>
              </a:r>
              <a:endParaRPr lang="en-GB" sz="800" b="1" dirty="0"/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5579058" y="413334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T x D</a:t>
              </a:r>
              <a:endParaRPr lang="en-GB" sz="800" b="1" dirty="0"/>
            </a:p>
          </p:txBody>
        </p:sp>
      </p:grpSp>
      <p:sp>
        <p:nvSpPr>
          <p:cNvPr id="86" name="TextBox 85"/>
          <p:cNvSpPr txBox="1"/>
          <p:nvPr/>
        </p:nvSpPr>
        <p:spPr>
          <a:xfrm>
            <a:off x="5393638" y="3444859"/>
            <a:ext cx="5100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 smtClean="0"/>
              <a:t> </a:t>
            </a:r>
            <a:r>
              <a:rPr lang="en-GB" sz="600" b="1" dirty="0" smtClean="0"/>
              <a:t>(p=0.056)</a:t>
            </a:r>
          </a:p>
        </p:txBody>
      </p:sp>
      <p:sp>
        <p:nvSpPr>
          <p:cNvPr id="87" name="Oval 86"/>
          <p:cNvSpPr/>
          <p:nvPr/>
        </p:nvSpPr>
        <p:spPr>
          <a:xfrm>
            <a:off x="5391195" y="3527713"/>
            <a:ext cx="70339" cy="63304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8" name="Oval 87"/>
          <p:cNvSpPr/>
          <p:nvPr/>
        </p:nvSpPr>
        <p:spPr>
          <a:xfrm>
            <a:off x="5391194" y="3627347"/>
            <a:ext cx="70339" cy="63304"/>
          </a:xfrm>
          <a:prstGeom prst="ellipse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9" name="Oval 88"/>
          <p:cNvSpPr/>
          <p:nvPr/>
        </p:nvSpPr>
        <p:spPr>
          <a:xfrm>
            <a:off x="2093572" y="8224397"/>
            <a:ext cx="70339" cy="69634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0" name="Oval 89"/>
          <p:cNvSpPr/>
          <p:nvPr/>
        </p:nvSpPr>
        <p:spPr>
          <a:xfrm>
            <a:off x="2093572" y="8341260"/>
            <a:ext cx="70339" cy="69634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1" name="Oval 90"/>
          <p:cNvSpPr/>
          <p:nvPr/>
        </p:nvSpPr>
        <p:spPr>
          <a:xfrm>
            <a:off x="1914912" y="6740209"/>
            <a:ext cx="70339" cy="63304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2" name="Oval 91"/>
          <p:cNvSpPr/>
          <p:nvPr/>
        </p:nvSpPr>
        <p:spPr>
          <a:xfrm>
            <a:off x="3775834" y="6688497"/>
            <a:ext cx="70339" cy="63304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" name="Oval 92"/>
          <p:cNvSpPr/>
          <p:nvPr/>
        </p:nvSpPr>
        <p:spPr>
          <a:xfrm>
            <a:off x="2093572" y="8467822"/>
            <a:ext cx="70339" cy="6963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" name="Oval 93"/>
          <p:cNvSpPr/>
          <p:nvPr/>
        </p:nvSpPr>
        <p:spPr>
          <a:xfrm>
            <a:off x="1914912" y="7018771"/>
            <a:ext cx="70339" cy="63304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" name="Oval 94"/>
          <p:cNvSpPr/>
          <p:nvPr/>
        </p:nvSpPr>
        <p:spPr>
          <a:xfrm>
            <a:off x="2093572" y="8586676"/>
            <a:ext cx="70339" cy="69634"/>
          </a:xfrm>
          <a:prstGeom prst="ellipse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" name="Oval 95"/>
          <p:cNvSpPr/>
          <p:nvPr/>
        </p:nvSpPr>
        <p:spPr>
          <a:xfrm>
            <a:off x="1914912" y="6883941"/>
            <a:ext cx="70339" cy="63304"/>
          </a:xfrm>
          <a:prstGeom prst="ellipse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" name="Oval 96"/>
          <p:cNvSpPr/>
          <p:nvPr/>
        </p:nvSpPr>
        <p:spPr>
          <a:xfrm>
            <a:off x="3775833" y="6830042"/>
            <a:ext cx="70339" cy="63304"/>
          </a:xfrm>
          <a:prstGeom prst="ellipse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" name="Oval 97"/>
          <p:cNvSpPr/>
          <p:nvPr/>
        </p:nvSpPr>
        <p:spPr>
          <a:xfrm>
            <a:off x="3775833" y="6970822"/>
            <a:ext cx="70339" cy="63304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aphicFrame>
        <p:nvGraphicFramePr>
          <p:cNvPr id="99" name="Chart 9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2026400"/>
              </p:ext>
            </p:extLst>
          </p:nvPr>
        </p:nvGraphicFramePr>
        <p:xfrm>
          <a:off x="1485121" y="6368517"/>
          <a:ext cx="1891064" cy="14402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0" name="Chart 9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2310815"/>
              </p:ext>
            </p:extLst>
          </p:nvPr>
        </p:nvGraphicFramePr>
        <p:xfrm>
          <a:off x="3358096" y="6370694"/>
          <a:ext cx="1891064" cy="14402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1" name="Chart 10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7247694"/>
              </p:ext>
            </p:extLst>
          </p:nvPr>
        </p:nvGraphicFramePr>
        <p:xfrm>
          <a:off x="1556905" y="7880274"/>
          <a:ext cx="1891064" cy="14402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2" name="Chart 10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5808177"/>
              </p:ext>
            </p:extLst>
          </p:nvPr>
        </p:nvGraphicFramePr>
        <p:xfrm>
          <a:off x="3429880" y="7880274"/>
          <a:ext cx="1891064" cy="14402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05" name="Chart 10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6615665"/>
              </p:ext>
            </p:extLst>
          </p:nvPr>
        </p:nvGraphicFramePr>
        <p:xfrm>
          <a:off x="3033627" y="3280699"/>
          <a:ext cx="2950663" cy="20796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pSp>
        <p:nvGrpSpPr>
          <p:cNvPr id="106" name="Group 105"/>
          <p:cNvGrpSpPr/>
          <p:nvPr/>
        </p:nvGrpSpPr>
        <p:grpSpPr>
          <a:xfrm>
            <a:off x="2504042" y="159125"/>
            <a:ext cx="1852338" cy="860426"/>
            <a:chOff x="2189735" y="70545"/>
            <a:chExt cx="1852338" cy="860426"/>
          </a:xfrm>
        </p:grpSpPr>
        <p:sp>
          <p:nvSpPr>
            <p:cNvPr id="107" name="Rectangle 106"/>
            <p:cNvSpPr/>
            <p:nvPr/>
          </p:nvSpPr>
          <p:spPr>
            <a:xfrm>
              <a:off x="2189735" y="306865"/>
              <a:ext cx="130073" cy="118368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8" name="Rectangle 107"/>
            <p:cNvSpPr/>
            <p:nvPr/>
          </p:nvSpPr>
          <p:spPr>
            <a:xfrm>
              <a:off x="2189735" y="459265"/>
              <a:ext cx="130073" cy="11836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9" name="Rectangle 108"/>
            <p:cNvSpPr/>
            <p:nvPr/>
          </p:nvSpPr>
          <p:spPr>
            <a:xfrm>
              <a:off x="2189735" y="611665"/>
              <a:ext cx="130073" cy="118368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0" name="Rectangle 109"/>
            <p:cNvSpPr/>
            <p:nvPr/>
          </p:nvSpPr>
          <p:spPr>
            <a:xfrm>
              <a:off x="2189735" y="764065"/>
              <a:ext cx="130073" cy="118368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1" name="Rectangle 110"/>
            <p:cNvSpPr/>
            <p:nvPr/>
          </p:nvSpPr>
          <p:spPr>
            <a:xfrm>
              <a:off x="3115904" y="306865"/>
              <a:ext cx="130073" cy="118368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2" name="Rectangle 111"/>
            <p:cNvSpPr/>
            <p:nvPr/>
          </p:nvSpPr>
          <p:spPr>
            <a:xfrm>
              <a:off x="3115904" y="459265"/>
              <a:ext cx="130073" cy="118368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3" name="Rectangle 112"/>
            <p:cNvSpPr/>
            <p:nvPr/>
          </p:nvSpPr>
          <p:spPr>
            <a:xfrm>
              <a:off x="3115904" y="611665"/>
              <a:ext cx="130073" cy="118368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4" name="Rectangle 113"/>
            <p:cNvSpPr/>
            <p:nvPr/>
          </p:nvSpPr>
          <p:spPr>
            <a:xfrm>
              <a:off x="3115904" y="764065"/>
              <a:ext cx="130073" cy="118368"/>
            </a:xfrm>
            <a:prstGeom prst="rect">
              <a:avLst/>
            </a:prstGeom>
            <a:solidFill>
              <a:schemeClr val="accent6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2254771" y="258327"/>
              <a:ext cx="7008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 VEHICLE</a:t>
              </a:r>
              <a:endParaRPr lang="en-GB" sz="800" b="1" dirty="0"/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2254771" y="563127"/>
              <a:ext cx="8082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P465L VEHICLE</a:t>
              </a:r>
              <a:endParaRPr lang="en-GB" sz="800" b="1" dirty="0"/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2254771" y="410727"/>
              <a:ext cx="75373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 WY14643</a:t>
              </a:r>
              <a:endParaRPr lang="en-GB" sz="800" b="1" dirty="0"/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2254771" y="715527"/>
              <a:ext cx="8611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P465L WY14643</a:t>
              </a:r>
              <a:endParaRPr lang="en-GB" sz="800" b="1" dirty="0"/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3180940" y="258327"/>
              <a:ext cx="7008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 VEHICLE</a:t>
              </a:r>
              <a:endParaRPr lang="en-GB" sz="800" b="1" dirty="0"/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3180940" y="563127"/>
              <a:ext cx="8082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P465L VEHICLE</a:t>
              </a:r>
              <a:endParaRPr lang="en-GB" sz="800" b="1" dirty="0"/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3180940" y="410727"/>
              <a:ext cx="75373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 WY14643</a:t>
              </a:r>
              <a:endParaRPr lang="en-GB" sz="800" b="1" dirty="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3180940" y="715527"/>
              <a:ext cx="8611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P465L WY14643</a:t>
              </a:r>
              <a:endParaRPr lang="en-GB" sz="800" b="1" dirty="0"/>
            </a:p>
          </p:txBody>
        </p:sp>
        <p:cxnSp>
          <p:nvCxnSpPr>
            <p:cNvPr id="123" name="Straight Connector 122"/>
            <p:cNvCxnSpPr/>
            <p:nvPr/>
          </p:nvCxnSpPr>
          <p:spPr>
            <a:xfrm>
              <a:off x="2189735" y="258327"/>
              <a:ext cx="722964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traight Connector 123"/>
            <p:cNvCxnSpPr/>
            <p:nvPr/>
          </p:nvCxnSpPr>
          <p:spPr>
            <a:xfrm>
              <a:off x="3109331" y="259087"/>
              <a:ext cx="722964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TextBox 124"/>
            <p:cNvSpPr txBox="1"/>
            <p:nvPr/>
          </p:nvSpPr>
          <p:spPr>
            <a:xfrm>
              <a:off x="2201872" y="70545"/>
              <a:ext cx="6799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CHOW DIET</a:t>
              </a:r>
              <a:endParaRPr lang="en-GB" sz="800" b="1" dirty="0"/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3183715" y="70545"/>
              <a:ext cx="5741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HFD DIET</a:t>
              </a:r>
              <a:endParaRPr lang="en-GB" sz="800" b="1" dirty="0"/>
            </a:p>
          </p:txBody>
        </p:sp>
      </p:grpSp>
      <p:sp>
        <p:nvSpPr>
          <p:cNvPr id="127" name="TextBox 126"/>
          <p:cNvSpPr txBox="1"/>
          <p:nvPr/>
        </p:nvSpPr>
        <p:spPr>
          <a:xfrm>
            <a:off x="252089" y="759429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sp>
        <p:nvSpPr>
          <p:cNvPr id="128" name="TextBox 127"/>
          <p:cNvSpPr txBox="1"/>
          <p:nvPr/>
        </p:nvSpPr>
        <p:spPr>
          <a:xfrm>
            <a:off x="189629" y="636851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5385" y="1188502"/>
            <a:ext cx="2370559" cy="209458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74839" y="1204522"/>
            <a:ext cx="2528875" cy="200682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45651" y="3322059"/>
            <a:ext cx="2493672" cy="2011717"/>
          </a:xfrm>
          <a:prstGeom prst="rect">
            <a:avLst/>
          </a:prstGeom>
        </p:spPr>
      </p:pic>
      <p:sp>
        <p:nvSpPr>
          <p:cNvPr id="63" name="Oval 62"/>
          <p:cNvSpPr/>
          <p:nvPr/>
        </p:nvSpPr>
        <p:spPr>
          <a:xfrm>
            <a:off x="1094682" y="3705499"/>
            <a:ext cx="70339" cy="63304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9" name="Oval 78"/>
          <p:cNvSpPr/>
          <p:nvPr/>
        </p:nvSpPr>
        <p:spPr>
          <a:xfrm>
            <a:off x="3954472" y="1428657"/>
            <a:ext cx="70339" cy="63304"/>
          </a:xfrm>
          <a:prstGeom prst="ellipse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0" name="Oval 79"/>
          <p:cNvSpPr/>
          <p:nvPr/>
        </p:nvSpPr>
        <p:spPr>
          <a:xfrm>
            <a:off x="1094682" y="1642655"/>
            <a:ext cx="70339" cy="63304"/>
          </a:xfrm>
          <a:prstGeom prst="ellipse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1" name="Oval 80"/>
          <p:cNvSpPr/>
          <p:nvPr/>
        </p:nvSpPr>
        <p:spPr>
          <a:xfrm>
            <a:off x="4106872" y="1581057"/>
            <a:ext cx="70339" cy="63304"/>
          </a:xfrm>
          <a:prstGeom prst="ellipse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2" name="Oval 81"/>
          <p:cNvSpPr/>
          <p:nvPr/>
        </p:nvSpPr>
        <p:spPr>
          <a:xfrm>
            <a:off x="1094682" y="1537693"/>
            <a:ext cx="70339" cy="63304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79539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129</TotalTime>
  <Words>63</Words>
  <Application>Microsoft Office PowerPoint</Application>
  <PresentationFormat>A4 Paper (210x297 mm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Cambridg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io Rodriguez-Cuenca</dc:creator>
  <cp:lastModifiedBy>Sergio Rodriguez-Cuenca</cp:lastModifiedBy>
  <cp:revision>277</cp:revision>
  <cp:lastPrinted>2017-08-07T10:49:05Z</cp:lastPrinted>
  <dcterms:created xsi:type="dcterms:W3CDTF">2017-01-24T20:07:34Z</dcterms:created>
  <dcterms:modified xsi:type="dcterms:W3CDTF">2018-05-04T09:35:08Z</dcterms:modified>
</cp:coreProperties>
</file>